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2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00CCCC"/>
    <a:srgbClr val="FBC69B"/>
    <a:srgbClr val="9CD1E0"/>
    <a:srgbClr val="CC99FF"/>
    <a:srgbClr val="96210A"/>
    <a:srgbClr val="3CD2D2"/>
    <a:srgbClr val="ECBE4A"/>
    <a:srgbClr val="EEA1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6391" autoAdjust="0"/>
    <p:restoredTop sz="98324" autoAdjust="0"/>
  </p:normalViewPr>
  <p:slideViewPr>
    <p:cSldViewPr>
      <p:cViewPr>
        <p:scale>
          <a:sx n="100" d="100"/>
          <a:sy n="100" d="100"/>
        </p:scale>
        <p:origin x="-2766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D78651-8FB6-44F5-8BFB-89520D5BAA29}" type="datetimeFigureOut">
              <a:rPr lang="en-US" smtClean="0"/>
              <a:t>3/2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FB5471-24C0-49CE-9D12-F21DD23384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73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56"/>
          <a:stretch/>
        </p:blipFill>
        <p:spPr bwMode="auto">
          <a:xfrm>
            <a:off x="6793984" y="503554"/>
            <a:ext cx="1973269" cy="5895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51" b="7370"/>
          <a:stretch/>
        </p:blipFill>
        <p:spPr bwMode="auto">
          <a:xfrm>
            <a:off x="1004935" y="524581"/>
            <a:ext cx="1993604" cy="3267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68" b="8812"/>
          <a:stretch/>
        </p:blipFill>
        <p:spPr bwMode="auto">
          <a:xfrm>
            <a:off x="3749404" y="506045"/>
            <a:ext cx="1928975" cy="3025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855" b="12926"/>
          <a:stretch/>
        </p:blipFill>
        <p:spPr bwMode="auto">
          <a:xfrm>
            <a:off x="967721" y="4158249"/>
            <a:ext cx="1954219" cy="140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94" b="14622"/>
          <a:stretch/>
        </p:blipFill>
        <p:spPr bwMode="auto">
          <a:xfrm>
            <a:off x="3880325" y="4117697"/>
            <a:ext cx="1880773" cy="13336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0" y="40306"/>
            <a:ext cx="7961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2</a:t>
            </a:r>
            <a:endParaRPr lang="en-US" sz="1200" dirty="0">
              <a:latin typeface="+mj-lt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005703" y="317305"/>
            <a:ext cx="1723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cs typeface="Times New Roman" panose="02020603050405020304" pitchFamily="18" charset="0"/>
              </a:rPr>
              <a:t>A)     </a:t>
            </a:r>
            <a:r>
              <a:rPr lang="en-US" sz="1200" dirty="0" smtClean="0"/>
              <a:t>Cluster 8</a:t>
            </a:r>
            <a:endParaRPr lang="en-US" sz="1200" dirty="0"/>
          </a:p>
        </p:txBody>
      </p:sp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445981"/>
              </p:ext>
            </p:extLst>
          </p:nvPr>
        </p:nvGraphicFramePr>
        <p:xfrm>
          <a:off x="673990" y="3818271"/>
          <a:ext cx="2386584" cy="16459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B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B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B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P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P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S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S3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C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E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E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F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F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F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J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J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G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G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J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R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b"/>
                </a:tc>
              </a:tr>
            </a:tbl>
          </a:graphicData>
        </a:graphic>
      </p:graphicFrame>
      <p:cxnSp>
        <p:nvCxnSpPr>
          <p:cNvPr id="22" name="Straight Connector 21"/>
          <p:cNvCxnSpPr/>
          <p:nvPr/>
        </p:nvCxnSpPr>
        <p:spPr>
          <a:xfrm>
            <a:off x="1683380" y="3821091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2587991" y="380847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8323529"/>
              </p:ext>
            </p:extLst>
          </p:nvPr>
        </p:nvGraphicFramePr>
        <p:xfrm>
          <a:off x="3546097" y="3524464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26" name="Straight Connector 25"/>
          <p:cNvCxnSpPr/>
          <p:nvPr/>
        </p:nvCxnSpPr>
        <p:spPr>
          <a:xfrm>
            <a:off x="4555487" y="3527284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140480" y="3526979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210245" y="353151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" name="Tab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6176876"/>
              </p:ext>
            </p:extLst>
          </p:nvPr>
        </p:nvGraphicFramePr>
        <p:xfrm>
          <a:off x="591621" y="5545750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30" name="Straight Connector 29"/>
          <p:cNvCxnSpPr/>
          <p:nvPr/>
        </p:nvCxnSpPr>
        <p:spPr>
          <a:xfrm>
            <a:off x="1684141" y="5548570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505622" y="554826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1268876" y="554826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3" name="Table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780958"/>
              </p:ext>
            </p:extLst>
          </p:nvPr>
        </p:nvGraphicFramePr>
        <p:xfrm>
          <a:off x="3627421" y="5542196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34" name="Straight Connector 33"/>
          <p:cNvCxnSpPr/>
          <p:nvPr/>
        </p:nvCxnSpPr>
        <p:spPr>
          <a:xfrm>
            <a:off x="4629844" y="5545016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122315" y="5544711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7" name="Table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1539838"/>
              </p:ext>
            </p:extLst>
          </p:nvPr>
        </p:nvGraphicFramePr>
        <p:xfrm>
          <a:off x="6587326" y="6389753"/>
          <a:ext cx="2445258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140970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38" name="Straight Connector 37"/>
          <p:cNvCxnSpPr/>
          <p:nvPr/>
        </p:nvCxnSpPr>
        <p:spPr>
          <a:xfrm>
            <a:off x="7594989" y="6392573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8497568" y="6392268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7016778" y="639942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726462" y="317305"/>
            <a:ext cx="1723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(B)     </a:t>
            </a:r>
            <a:r>
              <a:rPr lang="en-US" sz="1200" dirty="0" smtClean="0"/>
              <a:t>Cluster 9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6793984" y="317305"/>
            <a:ext cx="1723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(C)     </a:t>
            </a:r>
            <a:r>
              <a:rPr lang="en-US" sz="1200" dirty="0" smtClean="0"/>
              <a:t>Cluster 40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952046" y="3960265"/>
            <a:ext cx="1723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(D)     </a:t>
            </a:r>
            <a:r>
              <a:rPr lang="en-US" sz="1200" dirty="0" smtClean="0"/>
              <a:t>Cluster 21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3824828" y="3884106"/>
            <a:ext cx="1723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(E)     </a:t>
            </a:r>
            <a:r>
              <a:rPr lang="en-US" sz="1200" dirty="0" smtClean="0"/>
              <a:t>Cluster 45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10343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752</TotalTime>
  <Words>172</Words>
  <Application>Microsoft Office PowerPoint</Application>
  <PresentationFormat>On-screen Show (4:3)</PresentationFormat>
  <Paragraphs>1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 Bai</dc:creator>
  <cp:lastModifiedBy>Kenong Xu</cp:lastModifiedBy>
  <cp:revision>908</cp:revision>
  <cp:lastPrinted>2014-04-18T18:26:45Z</cp:lastPrinted>
  <dcterms:created xsi:type="dcterms:W3CDTF">2006-08-16T00:00:00Z</dcterms:created>
  <dcterms:modified xsi:type="dcterms:W3CDTF">2015-03-21T19:29:38Z</dcterms:modified>
</cp:coreProperties>
</file>